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7" r:id="rId3"/>
    <p:sldId id="258" r:id="rId4"/>
    <p:sldId id="259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E6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87" autoAdjust="0"/>
    <p:restoredTop sz="94653"/>
  </p:normalViewPr>
  <p:slideViewPr>
    <p:cSldViewPr snapToGrid="0">
      <p:cViewPr>
        <p:scale>
          <a:sx n="214" d="100"/>
          <a:sy n="214" d="100"/>
        </p:scale>
        <p:origin x="2288" y="144"/>
      </p:cViewPr>
      <p:guideLst>
        <p:guide orient="horz" pos="37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27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061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455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639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72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491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256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263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64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805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241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A9E5D-4303-46E3-B654-78D5D37811D4}" type="datetimeFigureOut">
              <a:rPr lang="en-US" smtClean="0"/>
              <a:t>4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A1133-04DC-467C-B5A5-4716583CD3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70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4" Type="http://schemas.openxmlformats.org/officeDocument/2006/relationships/image" Target="../media/image8.tiff"/><Relationship Id="rId5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4" Type="http://schemas.openxmlformats.org/officeDocument/2006/relationships/image" Target="../media/image12.tiff"/><Relationship Id="rId5" Type="http://schemas.openxmlformats.org/officeDocument/2006/relationships/image" Target="../media/image13.tiff"/><Relationship Id="rId6" Type="http://schemas.openxmlformats.org/officeDocument/2006/relationships/image" Target="../media/image14.tiff"/><Relationship Id="rId7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4" Type="http://schemas.openxmlformats.org/officeDocument/2006/relationships/image" Target="../media/image18.tiff"/><Relationship Id="rId5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1450" y="473529"/>
            <a:ext cx="11881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: Fig.1 </a:t>
            </a:r>
            <a:r>
              <a:rPr lang="en-US" sz="16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4643235" y="1711459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867445" y="1588348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Arrow Connector 20"/>
          <p:cNvCxnSpPr>
            <a:cxnSpLocks noChangeAspect="1"/>
          </p:cNvCxnSpPr>
          <p:nvPr/>
        </p:nvCxnSpPr>
        <p:spPr>
          <a:xfrm flipH="1">
            <a:off x="2743003" y="4323805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938503" y="4200694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 flipH="1">
            <a:off x="5253131" y="4167296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434492" y="4044881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2745436" y="6948763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939342" y="6825652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5245291" y="6594759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5435331" y="6471648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2260786" y="1165029"/>
            <a:ext cx="2367378" cy="1828800"/>
            <a:chOff x="1796142" y="628651"/>
            <a:chExt cx="3265715" cy="2522766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37" t="5531" r="9144" b="13640"/>
            <a:stretch/>
          </p:blipFill>
          <p:spPr>
            <a:xfrm>
              <a:off x="1796142" y="628651"/>
              <a:ext cx="3265715" cy="252276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" name="Rectangle 1"/>
            <p:cNvSpPr/>
            <p:nvPr/>
          </p:nvSpPr>
          <p:spPr>
            <a:xfrm>
              <a:off x="1924050" y="1241267"/>
              <a:ext cx="2286000" cy="454183"/>
            </a:xfrm>
            <a:prstGeom prst="rect">
              <a:avLst/>
            </a:prstGeom>
            <a:noFill/>
            <a:ln w="1270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270207" y="875293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 1 </a:t>
            </a:r>
            <a:r>
              <a:rPr lang="en-US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37" name="Group 36"/>
          <p:cNvGrpSpPr>
            <a:grpSpLocks noChangeAspect="1"/>
          </p:cNvGrpSpPr>
          <p:nvPr/>
        </p:nvGrpSpPr>
        <p:grpSpPr>
          <a:xfrm>
            <a:off x="1733514" y="3629815"/>
            <a:ext cx="1006734" cy="1828800"/>
            <a:chOff x="873232" y="3509070"/>
            <a:chExt cx="1379765" cy="2506436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46" t="9978" r="57773" b="9717"/>
            <a:stretch/>
          </p:blipFill>
          <p:spPr>
            <a:xfrm>
              <a:off x="873232" y="3509070"/>
              <a:ext cx="1379765" cy="250643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3" name="Rectangle 2"/>
            <p:cNvSpPr>
              <a:spLocks noChangeAspect="1"/>
            </p:cNvSpPr>
            <p:nvPr/>
          </p:nvSpPr>
          <p:spPr>
            <a:xfrm>
              <a:off x="873232" y="4446533"/>
              <a:ext cx="1212191" cy="258817"/>
            </a:xfrm>
            <a:prstGeom prst="rect">
              <a:avLst/>
            </a:prstGeom>
            <a:noFill/>
            <a:ln w="1270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1696508" y="3332260"/>
            <a:ext cx="12121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FKFB 3 WCE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40" name="Group 39"/>
          <p:cNvGrpSpPr>
            <a:grpSpLocks noChangeAspect="1"/>
          </p:cNvGrpSpPr>
          <p:nvPr/>
        </p:nvGrpSpPr>
        <p:grpSpPr>
          <a:xfrm>
            <a:off x="3806114" y="3639929"/>
            <a:ext cx="1438338" cy="1828800"/>
            <a:chOff x="3319341" y="3497265"/>
            <a:chExt cx="1958450" cy="2490107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98" t="8148" r="23094" b="12070"/>
            <a:stretch/>
          </p:blipFill>
          <p:spPr>
            <a:xfrm>
              <a:off x="3319341" y="3497265"/>
              <a:ext cx="1958450" cy="249010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32" name="Rectangle 31"/>
            <p:cNvSpPr/>
            <p:nvPr/>
          </p:nvSpPr>
          <p:spPr>
            <a:xfrm>
              <a:off x="3319341" y="4182676"/>
              <a:ext cx="1119309" cy="258817"/>
            </a:xfrm>
            <a:prstGeom prst="rect">
              <a:avLst/>
            </a:prstGeom>
            <a:noFill/>
            <a:ln w="1270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3802686" y="3349628"/>
            <a:ext cx="12779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FKFB 3 Nuclei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62" t="10686" r="33857" b="9270"/>
          <a:stretch/>
        </p:blipFill>
        <p:spPr>
          <a:xfrm>
            <a:off x="1733514" y="6114829"/>
            <a:ext cx="1010024" cy="18288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3" name="Rectangle 32"/>
          <p:cNvSpPr/>
          <p:nvPr/>
        </p:nvSpPr>
        <p:spPr>
          <a:xfrm>
            <a:off x="1805498" y="6779285"/>
            <a:ext cx="934750" cy="292587"/>
          </a:xfrm>
          <a:prstGeom prst="rect">
            <a:avLst/>
          </a:prstGeom>
          <a:noFill/>
          <a:ln w="1270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1696508" y="5829079"/>
            <a:ext cx="1133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 WCE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46" name="Group 45"/>
          <p:cNvGrpSpPr>
            <a:grpSpLocks noChangeAspect="1"/>
          </p:cNvGrpSpPr>
          <p:nvPr/>
        </p:nvGrpSpPr>
        <p:grpSpPr>
          <a:xfrm>
            <a:off x="3802687" y="6114829"/>
            <a:ext cx="1446307" cy="1828800"/>
            <a:chOff x="3319341" y="6351141"/>
            <a:chExt cx="1975758" cy="2498272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76" t="12042" r="23493" b="7915"/>
            <a:stretch/>
          </p:blipFill>
          <p:spPr>
            <a:xfrm>
              <a:off x="3319341" y="6351141"/>
              <a:ext cx="1975758" cy="24982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34" name="Rectangle 33"/>
            <p:cNvSpPr/>
            <p:nvPr/>
          </p:nvSpPr>
          <p:spPr>
            <a:xfrm>
              <a:off x="3336201" y="6865783"/>
              <a:ext cx="1102450" cy="200314"/>
            </a:xfrm>
            <a:prstGeom prst="rect">
              <a:avLst/>
            </a:prstGeom>
            <a:noFill/>
            <a:ln w="1270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TextBox 30"/>
          <p:cNvSpPr txBox="1"/>
          <p:nvPr/>
        </p:nvSpPr>
        <p:spPr>
          <a:xfrm>
            <a:off x="3802686" y="5829079"/>
            <a:ext cx="1195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RP-1 Nuclei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88738" y="151158"/>
            <a:ext cx="21114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>
                <a:latin typeface="Arial" charset="0"/>
                <a:ea typeface="Arial" charset="0"/>
                <a:cs typeface="Arial" charset="0"/>
              </a:rPr>
              <a:t>DATA SOURCE FILE</a:t>
            </a:r>
            <a:endParaRPr lang="en-US" sz="16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3218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1450" y="130629"/>
            <a:ext cx="11881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: Fig.2 </a:t>
            </a:r>
            <a:r>
              <a:rPr lang="en-US" sz="16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4656786" y="1057875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824665" y="932075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4599067" y="3540326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804635" y="3417215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4617414" y="5849134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804289" y="5723819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2232343" y="647370"/>
            <a:ext cx="2414953" cy="1828800"/>
            <a:chOff x="1434775" y="468282"/>
            <a:chExt cx="3270250" cy="247650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94" t="6694" r="9985" b="13960"/>
            <a:stretch/>
          </p:blipFill>
          <p:spPr>
            <a:xfrm>
              <a:off x="1434775" y="468282"/>
              <a:ext cx="3270250" cy="247650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6" name="Rectangle 25"/>
            <p:cNvSpPr/>
            <p:nvPr/>
          </p:nvSpPr>
          <p:spPr>
            <a:xfrm>
              <a:off x="1648586" y="844491"/>
              <a:ext cx="2815139" cy="314741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233270" y="361620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 1 </a:t>
            </a:r>
            <a:r>
              <a:rPr lang="en-US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13" name="Group 12"/>
          <p:cNvGrpSpPr>
            <a:grpSpLocks noChangeAspect="1"/>
          </p:cNvGrpSpPr>
          <p:nvPr/>
        </p:nvGrpSpPr>
        <p:grpSpPr>
          <a:xfrm>
            <a:off x="2232477" y="2758313"/>
            <a:ext cx="2356606" cy="1828800"/>
            <a:chOff x="1434775" y="3018969"/>
            <a:chExt cx="3232150" cy="2508250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66" t="11141" r="6589" b="8496"/>
            <a:stretch/>
          </p:blipFill>
          <p:spPr>
            <a:xfrm>
              <a:off x="1434775" y="3018969"/>
              <a:ext cx="3232150" cy="250825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7" name="Rectangle 26"/>
            <p:cNvSpPr/>
            <p:nvPr/>
          </p:nvSpPr>
          <p:spPr>
            <a:xfrm>
              <a:off x="1627630" y="3746640"/>
              <a:ext cx="2815139" cy="314741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232343" y="2468236"/>
            <a:ext cx="1168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FKFB3 WCE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19" name="Group 18"/>
          <p:cNvGrpSpPr>
            <a:grpSpLocks noChangeAspect="1"/>
          </p:cNvGrpSpPr>
          <p:nvPr/>
        </p:nvGrpSpPr>
        <p:grpSpPr>
          <a:xfrm>
            <a:off x="2232343" y="4869256"/>
            <a:ext cx="2380713" cy="1828800"/>
            <a:chOff x="1436864" y="5601405"/>
            <a:chExt cx="3232150" cy="2482851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00" t="7741" r="11355" b="12711"/>
            <a:stretch/>
          </p:blipFill>
          <p:spPr>
            <a:xfrm>
              <a:off x="1436864" y="5601405"/>
              <a:ext cx="3232150" cy="248285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8" name="Rectangle 27"/>
            <p:cNvSpPr/>
            <p:nvPr/>
          </p:nvSpPr>
          <p:spPr>
            <a:xfrm>
              <a:off x="1594795" y="6752314"/>
              <a:ext cx="1467670" cy="314741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231997" y="4580109"/>
            <a:ext cx="1133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 WCE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H="1">
            <a:off x="4626421" y="7368503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797662" y="7242703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oup 32"/>
          <p:cNvGrpSpPr>
            <a:grpSpLocks noChangeAspect="1"/>
          </p:cNvGrpSpPr>
          <p:nvPr/>
        </p:nvGrpSpPr>
        <p:grpSpPr>
          <a:xfrm>
            <a:off x="2231997" y="6980199"/>
            <a:ext cx="2392594" cy="1828800"/>
            <a:chOff x="1652587" y="1809751"/>
            <a:chExt cx="3233739" cy="2471737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40" t="16888" r="8374" b="3918"/>
            <a:stretch/>
          </p:blipFill>
          <p:spPr>
            <a:xfrm>
              <a:off x="1652587" y="1809751"/>
              <a:ext cx="3233739" cy="247173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35" name="Rectangle 34"/>
            <p:cNvSpPr/>
            <p:nvPr/>
          </p:nvSpPr>
          <p:spPr>
            <a:xfrm>
              <a:off x="3232909" y="2018882"/>
              <a:ext cx="1405758" cy="315686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2230165" y="6694449"/>
            <a:ext cx="1195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RP-1 Nuclei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5748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6" t="8276" r="18434" b="12072"/>
          <a:stretch/>
        </p:blipFill>
        <p:spPr>
          <a:xfrm>
            <a:off x="296906" y="914999"/>
            <a:ext cx="2386584" cy="18288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171450" y="130629"/>
            <a:ext cx="11881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: Fig.3 </a:t>
            </a:r>
            <a:r>
              <a:rPr lang="en-US" sz="16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2672083" y="1493557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822425" y="1370446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6085366" y="1795574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266347" y="1669774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H="1">
            <a:off x="6088541" y="1634943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269522" y="1512318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 flipH="1">
            <a:off x="2199394" y="4271774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2363098" y="4148087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1145772" y="1381847"/>
            <a:ext cx="1253014" cy="197527"/>
          </a:xfrm>
          <a:prstGeom prst="rect">
            <a:avLst/>
          </a:prstGeom>
          <a:noFill/>
          <a:ln w="19050">
            <a:solidFill>
              <a:srgbClr val="A3E65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9" name="TextBox 8"/>
          <p:cNvSpPr txBox="1"/>
          <p:nvPr/>
        </p:nvSpPr>
        <p:spPr>
          <a:xfrm>
            <a:off x="273015" y="648390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 1 </a:t>
            </a:r>
            <a:r>
              <a:rPr lang="en-US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20" name="Group 19"/>
          <p:cNvGrpSpPr>
            <a:grpSpLocks noChangeAspect="1"/>
          </p:cNvGrpSpPr>
          <p:nvPr/>
        </p:nvGrpSpPr>
        <p:grpSpPr>
          <a:xfrm>
            <a:off x="3686322" y="927501"/>
            <a:ext cx="2389330" cy="1828800"/>
            <a:chOff x="1397005" y="3040590"/>
            <a:chExt cx="3215640" cy="246126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53" t="9557" r="9450" b="11586"/>
            <a:stretch/>
          </p:blipFill>
          <p:spPr>
            <a:xfrm>
              <a:off x="1397005" y="3040590"/>
              <a:ext cx="3215640" cy="246126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8" name="Rectangle 27"/>
            <p:cNvSpPr/>
            <p:nvPr/>
          </p:nvSpPr>
          <p:spPr>
            <a:xfrm>
              <a:off x="2490108" y="3941016"/>
              <a:ext cx="1681844" cy="354663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3686322" y="651276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FKFB3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32" name="Group 31"/>
          <p:cNvGrpSpPr>
            <a:grpSpLocks noChangeAspect="1"/>
          </p:cNvGrpSpPr>
          <p:nvPr/>
        </p:nvGrpSpPr>
        <p:grpSpPr>
          <a:xfrm>
            <a:off x="300081" y="3356797"/>
            <a:ext cx="1890888" cy="1828800"/>
            <a:chOff x="1397005" y="5603108"/>
            <a:chExt cx="2552700" cy="2468881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82" t="7484" r="16704" b="13413"/>
            <a:stretch/>
          </p:blipFill>
          <p:spPr>
            <a:xfrm>
              <a:off x="1397005" y="5603108"/>
              <a:ext cx="2552700" cy="246888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9" name="Rectangle 28"/>
            <p:cNvSpPr/>
            <p:nvPr/>
          </p:nvSpPr>
          <p:spPr>
            <a:xfrm>
              <a:off x="1560292" y="6709167"/>
              <a:ext cx="1779814" cy="294581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296906" y="306364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6043446" y="4232609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227182" y="4112671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Group 34"/>
          <p:cNvGrpSpPr>
            <a:grpSpLocks noChangeAspect="1"/>
          </p:cNvGrpSpPr>
          <p:nvPr/>
        </p:nvGrpSpPr>
        <p:grpSpPr>
          <a:xfrm>
            <a:off x="3686322" y="3357724"/>
            <a:ext cx="2347331" cy="1828800"/>
            <a:chOff x="1824990" y="518159"/>
            <a:chExt cx="3208020" cy="2499361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13" t="5131" r="7775" b="14792"/>
            <a:stretch/>
          </p:blipFill>
          <p:spPr>
            <a:xfrm>
              <a:off x="1824990" y="518159"/>
              <a:ext cx="3208020" cy="249936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37" name="Rectangle 36"/>
            <p:cNvSpPr/>
            <p:nvPr/>
          </p:nvSpPr>
          <p:spPr>
            <a:xfrm>
              <a:off x="2906486" y="1549920"/>
              <a:ext cx="1725984" cy="336502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3686322" y="308057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h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675891" y="5511312"/>
            <a:ext cx="2698426" cy="2119424"/>
            <a:chOff x="273015" y="5503223"/>
            <a:chExt cx="2698426" cy="2119424"/>
          </a:xfrm>
        </p:grpSpPr>
        <p:cxnSp>
          <p:nvCxnSpPr>
            <p:cNvPr id="39" name="Straight Arrow Connector 38"/>
            <p:cNvCxnSpPr/>
            <p:nvPr/>
          </p:nvCxnSpPr>
          <p:spPr>
            <a:xfrm flipH="1">
              <a:off x="2182444" y="6769183"/>
              <a:ext cx="26125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2361979" y="664607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 flipH="1">
              <a:off x="2182444" y="6616089"/>
              <a:ext cx="26125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2361979" y="6491260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" name="Group 42"/>
            <p:cNvGrpSpPr>
              <a:grpSpLocks noChangeAspect="1"/>
            </p:cNvGrpSpPr>
            <p:nvPr/>
          </p:nvGrpSpPr>
          <p:grpSpPr>
            <a:xfrm>
              <a:off x="300094" y="5793847"/>
              <a:ext cx="1870773" cy="1828800"/>
              <a:chOff x="1824993" y="3110300"/>
              <a:chExt cx="2547258" cy="2490107"/>
            </a:xfrm>
          </p:grpSpPr>
          <p:pic>
            <p:nvPicPr>
              <p:cNvPr id="44" name="Picture 43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26" t="8147" r="23692" b="12071"/>
              <a:stretch/>
            </p:blipFill>
            <p:spPr>
              <a:xfrm>
                <a:off x="1824993" y="3110300"/>
                <a:ext cx="2547258" cy="2490107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45" name="Rectangle 44"/>
              <p:cNvSpPr/>
              <p:nvPr/>
            </p:nvSpPr>
            <p:spPr>
              <a:xfrm>
                <a:off x="1925112" y="4203096"/>
                <a:ext cx="1928431" cy="324773"/>
              </a:xfrm>
              <a:prstGeom prst="rect">
                <a:avLst/>
              </a:prstGeom>
              <a:noFill/>
              <a:ln w="19050"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273015" y="5503223"/>
              <a:ext cx="2342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 (second, re-incubation)</a:t>
              </a:r>
              <a:endParaRPr lang="en-US" sz="12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296906" y="5513889"/>
            <a:ext cx="2662880" cy="2114270"/>
            <a:chOff x="3723771" y="5508377"/>
            <a:chExt cx="2662880" cy="2114270"/>
          </a:xfrm>
        </p:grpSpPr>
        <p:cxnSp>
          <p:nvCxnSpPr>
            <p:cNvPr id="49" name="Straight Arrow Connector 48"/>
            <p:cNvCxnSpPr/>
            <p:nvPr/>
          </p:nvCxnSpPr>
          <p:spPr>
            <a:xfrm flipH="1">
              <a:off x="5605059" y="6807283"/>
              <a:ext cx="26125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5777189" y="668417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Group 50"/>
            <p:cNvGrpSpPr>
              <a:grpSpLocks noChangeAspect="1"/>
            </p:cNvGrpSpPr>
            <p:nvPr/>
          </p:nvGrpSpPr>
          <p:grpSpPr>
            <a:xfrm>
              <a:off x="3723771" y="5793847"/>
              <a:ext cx="1870499" cy="1828800"/>
              <a:chOff x="1824990" y="5701099"/>
              <a:chExt cx="2563587" cy="2506436"/>
            </a:xfrm>
          </p:grpSpPr>
          <p:pic>
            <p:nvPicPr>
              <p:cNvPr id="52" name="Picture 51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472" t="13079" r="7948" b="6616"/>
              <a:stretch/>
            </p:blipFill>
            <p:spPr>
              <a:xfrm>
                <a:off x="1824990" y="5701099"/>
                <a:ext cx="2563587" cy="2506436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53" name="Rectangle 52"/>
              <p:cNvSpPr/>
              <p:nvPr/>
            </p:nvSpPr>
            <p:spPr>
              <a:xfrm>
                <a:off x="1942270" y="6854396"/>
                <a:ext cx="1928431" cy="324773"/>
              </a:xfrm>
              <a:prstGeom prst="rect">
                <a:avLst/>
              </a:prstGeom>
              <a:noFill/>
              <a:ln w="19050"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3726165" y="5508377"/>
              <a:ext cx="10390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 (first)</a:t>
              </a:r>
              <a:endParaRPr lang="en-US" sz="12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83598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1450" y="130629"/>
            <a:ext cx="11881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: Fig.9 </a:t>
            </a:r>
            <a:r>
              <a:rPr lang="en-US" sz="1600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4178577" y="1499594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363620" y="1370736"/>
            <a:ext cx="6799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40734" y="687707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 1 </a:t>
            </a:r>
            <a:r>
              <a:rPr lang="en-US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4141917" y="2530607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320749" y="2402542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4143529" y="2287327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320749" y="2158199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58282" y="1972194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FKFB3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4156187" y="3442560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331594" y="3313585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58282" y="2911483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l.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s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3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 flipH="1">
            <a:off x="4156187" y="4670402"/>
            <a:ext cx="2612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315131" y="4544602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67178" y="4138314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95" t="61157" r="8364" b="13183"/>
          <a:stretch/>
        </p:blipFill>
        <p:spPr>
          <a:xfrm>
            <a:off x="1758400" y="3198611"/>
            <a:ext cx="2395632" cy="59436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8" name="Rectangle 27"/>
          <p:cNvSpPr/>
          <p:nvPr/>
        </p:nvSpPr>
        <p:spPr>
          <a:xfrm>
            <a:off x="2111763" y="3300253"/>
            <a:ext cx="1784032" cy="241260"/>
          </a:xfrm>
          <a:prstGeom prst="rect">
            <a:avLst/>
          </a:prstGeom>
          <a:noFill/>
          <a:ln w="190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37" name="Group 36"/>
          <p:cNvGrpSpPr>
            <a:grpSpLocks noChangeAspect="1"/>
          </p:cNvGrpSpPr>
          <p:nvPr/>
        </p:nvGrpSpPr>
        <p:grpSpPr>
          <a:xfrm>
            <a:off x="1759619" y="4425736"/>
            <a:ext cx="2395725" cy="530352"/>
            <a:chOff x="1442416" y="4778834"/>
            <a:chExt cx="3208565" cy="710294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24" t="63252" r="8156" b="13968"/>
            <a:stretch/>
          </p:blipFill>
          <p:spPr>
            <a:xfrm>
              <a:off x="1442416" y="4778834"/>
              <a:ext cx="3208565" cy="71029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9" name="Rectangle 28"/>
            <p:cNvSpPr/>
            <p:nvPr/>
          </p:nvSpPr>
          <p:spPr>
            <a:xfrm>
              <a:off x="1856733" y="4943017"/>
              <a:ext cx="2401584" cy="324773"/>
            </a:xfrm>
            <a:prstGeom prst="rect">
              <a:avLst/>
            </a:prstGeom>
            <a:noFill/>
            <a:ln w="19050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44" t="58016" r="7269" b="13444"/>
          <a:stretch/>
        </p:blipFill>
        <p:spPr>
          <a:xfrm>
            <a:off x="1751290" y="975428"/>
            <a:ext cx="2416027" cy="65836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6" name="Rectangle 25"/>
          <p:cNvSpPr/>
          <p:nvPr/>
        </p:nvSpPr>
        <p:spPr>
          <a:xfrm>
            <a:off x="2100664" y="1372725"/>
            <a:ext cx="1776730" cy="240272"/>
          </a:xfrm>
          <a:prstGeom prst="rect">
            <a:avLst/>
          </a:prstGeom>
          <a:noFill/>
          <a:ln w="190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1" t="61178" r="11298" b="24944"/>
          <a:stretch/>
        </p:blipFill>
        <p:spPr>
          <a:xfrm>
            <a:off x="1760102" y="2256341"/>
            <a:ext cx="2373122" cy="32004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7" name="Rectangle 26"/>
          <p:cNvSpPr/>
          <p:nvPr/>
        </p:nvSpPr>
        <p:spPr>
          <a:xfrm>
            <a:off x="2079666" y="2321185"/>
            <a:ext cx="1776262" cy="240209"/>
          </a:xfrm>
          <a:prstGeom prst="rect">
            <a:avLst/>
          </a:prstGeom>
          <a:noFill/>
          <a:ln w="190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</p:spTree>
    <p:extLst>
      <p:ext uri="{BB962C8B-B14F-4D97-AF65-F5344CB8AC3E}">
        <p14:creationId xmlns:p14="http://schemas.microsoft.com/office/powerpoint/2010/main" val="1737498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</TotalTime>
  <Words>112</Words>
  <Application>Microsoft Macintosh PowerPoint</Application>
  <PresentationFormat>Letter Paper (8.5x11 in)</PresentationFormat>
  <Paragraphs>4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Calibri Light</vt:lpstr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aging</dc:creator>
  <cp:lastModifiedBy>Microsoft Office User</cp:lastModifiedBy>
  <cp:revision>71</cp:revision>
  <cp:lastPrinted>2019-04-26T23:31:24Z</cp:lastPrinted>
  <dcterms:created xsi:type="dcterms:W3CDTF">2019-04-22T21:25:24Z</dcterms:created>
  <dcterms:modified xsi:type="dcterms:W3CDTF">2019-04-27T01:34:52Z</dcterms:modified>
</cp:coreProperties>
</file>